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17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3-6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2173835" y="785794"/>
          <a:ext cx="5970056" cy="5000650"/>
        </p:xfrm>
        <a:graphic>
          <a:graphicData uri="http://schemas.openxmlformats.org/drawingml/2006/table">
            <a:tbl>
              <a:tblPr/>
              <a:tblGrid>
                <a:gridCol w="390440"/>
                <a:gridCol w="253619"/>
                <a:gridCol w="253619"/>
                <a:gridCol w="266967"/>
                <a:gridCol w="253619"/>
                <a:gridCol w="253619"/>
                <a:gridCol w="253619"/>
                <a:gridCol w="253619"/>
                <a:gridCol w="253619"/>
                <a:gridCol w="253619"/>
                <a:gridCol w="253619"/>
                <a:gridCol w="253619"/>
                <a:gridCol w="253619"/>
                <a:gridCol w="253619"/>
                <a:gridCol w="253619"/>
                <a:gridCol w="253619"/>
                <a:gridCol w="253619"/>
                <a:gridCol w="253619"/>
                <a:gridCol w="240269"/>
                <a:gridCol w="253619"/>
                <a:gridCol w="253619"/>
                <a:gridCol w="253619"/>
                <a:gridCol w="253619"/>
              </a:tblGrid>
              <a:tr h="200026"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5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6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7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8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19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0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1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2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3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G24</a:t>
                      </a:r>
                    </a:p>
                  </a:txBody>
                  <a:tcPr marL="8048" marR="8048" marT="804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2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8048" marR="8048" marT="80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 rot="10800000">
            <a:off x="1687646" y="1391411"/>
            <a:ext cx="461665" cy="389497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Orange-spotted grouper linkage group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357686" y="446374"/>
            <a:ext cx="2097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ugu chromosomes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8</Words>
  <PresentationFormat>全屏显示(4:3)</PresentationFormat>
  <Paragraphs>57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dell</cp:lastModifiedBy>
  <cp:revision>1</cp:revision>
  <dcterms:modified xsi:type="dcterms:W3CDTF">2013-06-21T14:36:37Z</dcterms:modified>
</cp:coreProperties>
</file>